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1" d="100"/>
          <a:sy n="91" d="100"/>
        </p:scale>
        <p:origin x="102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704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4774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2360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7591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688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4008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2682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9856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3690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254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7840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4A131-4E96-4BC7-A4A2-4C8DFD6FB4D6}" type="datetimeFigureOut">
              <a:rPr lang="zh-CN" altLang="en-US" smtClean="0"/>
              <a:t>2023/10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B3DD06-B686-46B3-A98D-7145578871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956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636B59C-6CAB-49C9-B636-FA984FA470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9563" y="130293"/>
            <a:ext cx="2006359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8F2FA02-5008-49C8-920A-6369BF4A978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1027" y="1280111"/>
            <a:ext cx="2015627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31DDAD4-824D-4012-BA70-CBAE6959983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52"/>
          <a:stretch/>
        </p:blipFill>
        <p:spPr>
          <a:xfrm>
            <a:off x="4061759" y="2448559"/>
            <a:ext cx="2024895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C7B2BC1-88F9-45CD-8BCD-0BE656BDC6E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17"/>
          <a:stretch/>
        </p:blipFill>
        <p:spPr>
          <a:xfrm>
            <a:off x="4058931" y="3612984"/>
            <a:ext cx="2036991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00323BB-3B3A-42CA-959E-93FC0280AF6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95"/>
          <a:stretch/>
        </p:blipFill>
        <p:spPr>
          <a:xfrm>
            <a:off x="4058931" y="4762802"/>
            <a:ext cx="2036991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CDFF3C0A-8C00-490F-8711-EC97404C9B2A}"/>
              </a:ext>
            </a:extLst>
          </p:cNvPr>
          <p:cNvSpPr txBox="1"/>
          <p:nvPr/>
        </p:nvSpPr>
        <p:spPr>
          <a:xfrm>
            <a:off x="3819892" y="-4191"/>
            <a:ext cx="337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FD9541CA-C53B-42C3-9E28-E7A8E86C2C0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1284" y="127455"/>
            <a:ext cx="2032427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3182CF47-9B45-416A-8D1A-5DEF8361928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3747" y="1280111"/>
            <a:ext cx="2048436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FFEA21C-B30D-4CE4-AECB-918D7983775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1284" y="2460328"/>
            <a:ext cx="2048436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0F83E05-F60F-4047-9D47-E2A180FACB5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7622" y="3612984"/>
            <a:ext cx="2062098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3583E85-642E-490B-9859-95B3220018A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3261" y="4762802"/>
            <a:ext cx="2064481" cy="1080000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4A64B3B6-B4ED-4189-B739-B89020A7C85A}"/>
              </a:ext>
            </a:extLst>
          </p:cNvPr>
          <p:cNvSpPr txBox="1"/>
          <p:nvPr/>
        </p:nvSpPr>
        <p:spPr>
          <a:xfrm>
            <a:off x="6402537" y="-4191"/>
            <a:ext cx="315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8621F50-909A-4E55-9569-4498DB6ABEB7}"/>
              </a:ext>
            </a:extLst>
          </p:cNvPr>
          <p:cNvSpPr txBox="1"/>
          <p:nvPr/>
        </p:nvSpPr>
        <p:spPr>
          <a:xfrm>
            <a:off x="2177735" y="5891319"/>
            <a:ext cx="8765309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5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gure S1</a:t>
            </a:r>
            <a:r>
              <a:rPr lang="en-US" altLang="zh-CN" sz="15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A. Electropherograms showing the copy-number variants of locus </a:t>
            </a:r>
            <a:r>
              <a:rPr lang="en-US" altLang="zh-CN" sz="1500" kern="100" dirty="0">
                <a:latin typeface="Arial" panose="020B0604020202020204" pitchFamily="34" charset="0"/>
                <a:cs typeface="Arial" panose="020B0604020202020204" pitchFamily="34" charset="0"/>
              </a:rPr>
              <a:t>DYS385a/b in five samples </a:t>
            </a:r>
            <a:r>
              <a:rPr lang="en-US" altLang="zh-CN" sz="15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y Microreader™24Y Direct ID System. B. The copy-number variants of locus DYS385a/b in five samples checked by the </a:t>
            </a:r>
            <a:r>
              <a:rPr lang="en-US" altLang="zh-CN" sz="1500" kern="1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Yfiler</a:t>
            </a:r>
            <a:r>
              <a:rPr lang="en-US" altLang="zh-CN" sz="15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™ Plus PCR Amplification Kit. </a:t>
            </a:r>
            <a:endParaRPr lang="zh-CN" altLang="zh-CN" sz="1500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166255" y="95432"/>
            <a:ext cx="2160269" cy="3403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958260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8</TotalTime>
  <Words>54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傅俊江</dc:creator>
  <cp:lastModifiedBy>MDPI</cp:lastModifiedBy>
  <cp:revision>28</cp:revision>
  <dcterms:created xsi:type="dcterms:W3CDTF">2023-09-09T01:22:19Z</dcterms:created>
  <dcterms:modified xsi:type="dcterms:W3CDTF">2023-10-02T07:44:37Z</dcterms:modified>
</cp:coreProperties>
</file>